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85678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7179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9412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3294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8440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491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9314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2541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9788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5933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8547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0722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B7839-BD4E-4BF6-AA46-8C7E10ACC3A3}" type="datetimeFigureOut">
              <a:rPr lang="en-GB" smtClean="0"/>
              <a:t>03/03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8EDA89-4ECA-4E69-908B-83D7D578603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0389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32758" y="2748981"/>
            <a:ext cx="3247754" cy="3119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6961" y="2766786"/>
            <a:ext cx="3119215" cy="31104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079" y="2766786"/>
            <a:ext cx="3187769" cy="31104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7824" y="16916"/>
            <a:ext cx="3119215" cy="31104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30482"/>
            <a:ext cx="3050661" cy="31104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5" name="Textfeld 44"/>
          <p:cNvSpPr txBox="1"/>
          <p:nvPr/>
        </p:nvSpPr>
        <p:spPr>
          <a:xfrm>
            <a:off x="35496" y="16916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en-GB" dirty="0"/>
          </a:p>
        </p:txBody>
      </p:sp>
      <p:sp>
        <p:nvSpPr>
          <p:cNvPr id="46" name="Textfeld 45"/>
          <p:cNvSpPr txBox="1"/>
          <p:nvPr/>
        </p:nvSpPr>
        <p:spPr>
          <a:xfrm>
            <a:off x="2987824" y="16916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  <a:endParaRPr lang="en-GB" dirty="0"/>
          </a:p>
        </p:txBody>
      </p:sp>
      <p:sp>
        <p:nvSpPr>
          <p:cNvPr id="61" name="Textfeld 60"/>
          <p:cNvSpPr txBox="1"/>
          <p:nvPr/>
        </p:nvSpPr>
        <p:spPr>
          <a:xfrm>
            <a:off x="35496" y="2780928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C</a:t>
            </a:r>
            <a:endParaRPr lang="en-GB" dirty="0"/>
          </a:p>
        </p:txBody>
      </p:sp>
      <p:sp>
        <p:nvSpPr>
          <p:cNvPr id="62" name="Textfeld 61"/>
          <p:cNvSpPr txBox="1"/>
          <p:nvPr/>
        </p:nvSpPr>
        <p:spPr>
          <a:xfrm>
            <a:off x="2987824" y="2780928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D</a:t>
            </a:r>
            <a:endParaRPr lang="en-GB" dirty="0"/>
          </a:p>
        </p:txBody>
      </p:sp>
      <p:sp>
        <p:nvSpPr>
          <p:cNvPr id="2" name="Rechteck 1"/>
          <p:cNvSpPr/>
          <p:nvPr/>
        </p:nvSpPr>
        <p:spPr>
          <a:xfrm>
            <a:off x="35496" y="5751728"/>
            <a:ext cx="9037059" cy="1092607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</a:t>
            </a:r>
            <a:r>
              <a:rPr lang="en-US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GB" sz="1100" b="1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Expression of </a:t>
            </a:r>
            <a:r>
              <a:rPr lang="en-GB" sz="1100" b="1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Alk2 </a:t>
            </a:r>
            <a:r>
              <a:rPr lang="en-GB" sz="1100" b="1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and </a:t>
            </a:r>
            <a:r>
              <a:rPr lang="en-GB" sz="1100" b="1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cell-type markers </a:t>
            </a:r>
            <a:r>
              <a:rPr lang="en-GB" sz="1100" b="1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in different liver cell types. 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KC</a:t>
            </a:r>
            <a:r>
              <a:rPr lang="en-GB" sz="11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, HC or LSEC were isolated from human resected (non-malignant) liver tissue (from the surrounding of colorectal cancer metastases) and directly lysed for RNA purification. Macrophages (MP) were generated from monocytes isolated from the blood of healthy donors by 1-week culture in serum-containing medium. For comparison RNA samples of whole liver tissue were additionally </a:t>
            </a:r>
            <a:r>
              <a:rPr lang="en-GB" sz="1100" dirty="0" err="1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analyzed</a:t>
            </a:r>
            <a:r>
              <a:rPr lang="en-GB" sz="11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 (“liver”). 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Alk2 (A) as well as expression </a:t>
            </a:r>
            <a:r>
              <a:rPr lang="en-GB" sz="11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levels 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of CD68 (macrophage marker; B), albumin (HC marker; C), CD34 (endothelial marker; D) and </a:t>
            </a:r>
            <a:r>
              <a:rPr lang="el-GR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α</a:t>
            </a:r>
            <a:r>
              <a:rPr lang="de-DE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SMA (HSC/</a:t>
            </a:r>
            <a:r>
              <a:rPr lang="de-DE" sz="1100" dirty="0" err="1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myofibroblast</a:t>
            </a:r>
            <a:r>
              <a:rPr lang="de-DE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 </a:t>
            </a:r>
            <a:r>
              <a:rPr lang="de-DE" sz="1100" dirty="0" err="1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marker</a:t>
            </a:r>
            <a:r>
              <a:rPr lang="de-DE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; E) 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were </a:t>
            </a:r>
            <a:r>
              <a:rPr lang="en-GB" sz="11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determined by RT-qPCR and normalized as </a:t>
            </a:r>
            <a:r>
              <a:rPr lang="en-GB" sz="11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described in Fig. 1.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741174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8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1576466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SE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1994112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2411760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323528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de-DE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1158820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850126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8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1685418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SE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2103064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2520712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432480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de-DE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1267772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3765510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8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4600802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SE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5018448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5436096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3347864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de-DE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4183156" y="2165083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3802454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8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4637746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SE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5055392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5473040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3384808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de-DE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4220100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6824910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8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7660202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SE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8077848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/>
          <p:cNvSpPr txBox="1"/>
          <p:nvPr/>
        </p:nvSpPr>
        <p:spPr>
          <a:xfrm>
            <a:off x="8495496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P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feld 94"/>
          <p:cNvSpPr txBox="1"/>
          <p:nvPr/>
        </p:nvSpPr>
        <p:spPr>
          <a:xfrm>
            <a:off x="6407264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de-DE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7242556" y="4911551"/>
            <a:ext cx="7920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</a:p>
          <a:p>
            <a:pPr algn="ctr"/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n=3)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6098242" y="2780928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5556630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3</Words>
  <Application>Microsoft Office PowerPoint</Application>
  <PresentationFormat>Bildschirmpräsentation (4:3)</PresentationFormat>
  <Paragraphs>6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-heidelberg.d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reitkopf, Katja</dc:creator>
  <cp:lastModifiedBy>Breitkopf, Katja</cp:lastModifiedBy>
  <cp:revision>18</cp:revision>
  <cp:lastPrinted>2020-02-24T12:16:19Z</cp:lastPrinted>
  <dcterms:created xsi:type="dcterms:W3CDTF">2019-11-27T09:00:18Z</dcterms:created>
  <dcterms:modified xsi:type="dcterms:W3CDTF">2020-03-03T10:09:15Z</dcterms:modified>
</cp:coreProperties>
</file>